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2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</p:sldIdLst>
  <p:sldSz cx="9144000" cy="6858000"/>
  <p:notesSz cx="9144000" cy="6858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7CC05A-3A43-41E2-BAFA-12D261C01903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4983D81-7D27-4EDC-B740-90DB7AD54B94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FC3B6-F7DD-4041-9118-19C13E606F5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A14E80D-918B-4CCB-88EB-EE83F1C8024F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3D335CA-E792-4A1B-8242-9FEBFC627E7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CC0D30-670D-427D-A55B-0CC57B8DB515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5A8CC6F-277B-4A5A-B588-28BDD6B94F8A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B82CA25-9EBB-498C-9283-C0FB857B9CA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AAA453-95A2-4F96-AC9F-88CA868801BE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6F46AC-4290-4162-B888-7B771A60A2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342C2ED-FCEE-4585-BBFC-E0F6D2F35A4A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692DADD-86F4-4708-AD32-C6CCCEC7924E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B3D496CA-D6A9-488E-9A10-DF7E58EB76FD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828800" y="152280"/>
          <a:ext cx="6553080" cy="3054240"/>
        </p:xfrm>
        <a:graphic>
          <a:graphicData uri="http://schemas.openxmlformats.org/drawingml/2006/table">
            <a:tbl>
              <a:tblPr/>
              <a:tblGrid>
                <a:gridCol w="361800"/>
                <a:gridCol w="3152880"/>
                <a:gridCol w="430200"/>
                <a:gridCol w="636480"/>
                <a:gridCol w="770040"/>
                <a:gridCol w="590400"/>
                <a:gridCol w="611280"/>
              </a:tblGrid>
              <a:tr h="249480"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No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473b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Processe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473b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Siz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473b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Target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473b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Pathways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473b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zScor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473ba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1100" spc="-1" strike="noStrike">
                          <a:solidFill>
                            <a:srgbClr val="ffffff"/>
                          </a:solidFill>
                          <a:latin typeface="Times New Roman"/>
                          <a:ea typeface="Times New Roman"/>
                        </a:rPr>
                        <a:t>gScore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473ba"/>
                    </a:solidFill>
                  </a:tcPr>
                </a:tc>
              </a:tr>
              <a:tr h="102708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df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Wnt receptor signaling pathway (36.0%), canonical Wnt receptor signaling pathway (28.0%), embryonic organ development (34.0%), positive regulation of nitrogen compound metabolic process (50.0%), positive regulation of cellular metabolic process (56.0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4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7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6.9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5.68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</a:tr>
              <a:tr h="8715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df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feeding behavior (16.3%), behavior (26.5%), positive regulation of macrophage chemotaxis (8.2%), regulation of mononuclear cell migration (8.2%), regulation of macrophage chemotaxis (8.2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.4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3.4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</a:tr>
              <a:tr h="871560"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3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edf3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GB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regulation of metabolic process (79.6%), regulation of cellular metabolic process (75.5%), regulation of primary metabolic process (73.5%), regulation of macromolecule metabolic process (69.4%), regulation of cellular process (91.8%)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0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19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5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3.27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  <a:tc>
                  <a:txBody>
                    <a:bodyPr lIns="90000" rIns="90000" tIns="46800" bIns="46800" anchor="t">
                      <a:noAutofit/>
                    </a:bodyPr>
                    <a:p>
                      <a:pPr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  </a:t>
                      </a:r>
                      <a:r>
                        <a:rPr b="0" lang="en-US" sz="1100" spc="-1" strike="noStrike">
                          <a:solidFill>
                            <a:srgbClr val="000000"/>
                          </a:solidFill>
                          <a:latin typeface="Times New Roman"/>
                          <a:ea typeface="Times New Roman"/>
                        </a:rPr>
                        <a:t>29.52</a:t>
                      </a:r>
                      <a:endParaRPr b="0" lang="en-US" sz="11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6f9fb"/>
                    </a:solidFill>
                  </a:tcPr>
                </a:tc>
              </a:tr>
            </a:tbl>
          </a:graphicData>
        </a:graphic>
      </p:graphicFrame>
      <p:sp>
        <p:nvSpPr>
          <p:cNvPr id="42" name=""/>
          <p:cNvSpPr/>
          <p:nvPr/>
        </p:nvSpPr>
        <p:spPr>
          <a:xfrm>
            <a:off x="63360" y="68400"/>
            <a:ext cx="10602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600" spc="-1" strike="noStrike">
                <a:solidFill>
                  <a:srgbClr val="000000"/>
                </a:solidFill>
                <a:latin typeface="Arial"/>
              </a:rPr>
              <a:t>Figure S2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3" name=""/>
          <p:cNvSpPr/>
          <p:nvPr/>
        </p:nvSpPr>
        <p:spPr>
          <a:xfrm>
            <a:off x="1214640" y="442800"/>
            <a:ext cx="38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A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4" name="" descr=""/>
          <p:cNvPicPr/>
          <p:nvPr/>
        </p:nvPicPr>
        <p:blipFill>
          <a:blip r:embed="rId1"/>
          <a:stretch/>
        </p:blipFill>
        <p:spPr>
          <a:xfrm>
            <a:off x="1143000" y="609480"/>
            <a:ext cx="5257800" cy="5616720"/>
          </a:xfrm>
          <a:prstGeom prst="rect">
            <a:avLst/>
          </a:prstGeom>
          <a:ln w="0">
            <a:noFill/>
          </a:ln>
        </p:spPr>
      </p:pic>
      <p:sp>
        <p:nvSpPr>
          <p:cNvPr id="45" name=""/>
          <p:cNvSpPr/>
          <p:nvPr/>
        </p:nvSpPr>
        <p:spPr>
          <a:xfrm>
            <a:off x="459000" y="762120"/>
            <a:ext cx="38340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600" spc="-1" strike="noStrike">
                <a:solidFill>
                  <a:srgbClr val="000000"/>
                </a:solidFill>
                <a:latin typeface="Arial"/>
              </a:rPr>
              <a:t>B)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2-12-18T16:36:31Z</dcterms:created>
  <dc:creator>Ronchi_C</dc:creator>
  <dc:description/>
  <dc:language>en-US</dc:language>
  <cp:lastModifiedBy>cristina</cp:lastModifiedBy>
  <dcterms:modified xsi:type="dcterms:W3CDTF">2013-08-02T17:42:25Z</dcterms:modified>
  <cp:revision>14</cp:revision>
  <dc:subject/>
  <dc:title>Folie 1</dc:title>
</cp:coreProperties>
</file>